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310" r:id="rId2"/>
  </p:sldIdLst>
  <p:sldSz cx="6858000" cy="9906000" type="A4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7E77"/>
    <a:srgbClr val="FF8AD8"/>
    <a:srgbClr val="F2F2F2"/>
    <a:srgbClr val="FAFAFA"/>
    <a:srgbClr val="5C665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F2DE63D5-997A-4646-A377-4702673A728D}" styleName="Style léger 2 - Accentuation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87" autoAdjust="0"/>
    <p:restoredTop sz="94277"/>
  </p:normalViewPr>
  <p:slideViewPr>
    <p:cSldViewPr snapToGrid="0">
      <p:cViewPr varScale="1">
        <p:scale>
          <a:sx n="75" d="100"/>
          <a:sy n="75" d="100"/>
        </p:scale>
        <p:origin x="312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7E9E69-94B8-6846-8831-8FFB33FB9D64}" type="datetimeFigureOut">
              <a:rPr lang="fr-FR" smtClean="0"/>
              <a:t>24/10/202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9337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40363" cy="39100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1275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2FD0DA-937E-B24B-9D15-1C64ED810B6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84773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8715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9037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782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8332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1959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842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687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258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1590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8672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705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365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/>
          <p:cNvGrpSpPr/>
          <p:nvPr/>
        </p:nvGrpSpPr>
        <p:grpSpPr>
          <a:xfrm>
            <a:off x="402142" y="575741"/>
            <a:ext cx="6020369" cy="5795751"/>
            <a:chOff x="219403" y="1034957"/>
            <a:chExt cx="6020369" cy="5795751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9403" y="1142679"/>
              <a:ext cx="5985717" cy="5509581"/>
            </a:xfrm>
            <a:prstGeom prst="rect">
              <a:avLst/>
            </a:prstGeom>
            <a:solidFill>
              <a:schemeClr val="bg1"/>
            </a:solidFill>
          </p:spPr>
        </p:pic>
        <p:sp>
          <p:nvSpPr>
            <p:cNvPr id="5" name="Rectangle 4"/>
            <p:cNvSpPr/>
            <p:nvPr/>
          </p:nvSpPr>
          <p:spPr>
            <a:xfrm>
              <a:off x="4302249" y="3964883"/>
              <a:ext cx="193752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/equine/</a:t>
              </a:r>
              <a:r>
                <a:rPr lang="en-US" sz="800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Beuvron-en-Auge</a:t>
              </a:r>
              <a:r>
                <a:rPr 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/2/2009</a:t>
              </a:r>
              <a:endParaRPr lang="fr-FR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ectangle 5"/>
            <p:cNvSpPr/>
            <p:nvPr/>
          </p:nvSpPr>
          <p:spPr>
            <a:xfrm>
              <a:off x="1508381" y="1034957"/>
              <a:ext cx="110799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/equine/Paris/1/2018</a:t>
              </a:r>
              <a:endParaRPr lang="fr-FR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>
              <a:off x="1344074" y="3964883"/>
              <a:ext cx="142859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/equine/South Africa/4/2003</a:t>
              </a:r>
              <a:endParaRPr lang="fr-FR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>
              <a:off x="4322901" y="1034957"/>
              <a:ext cx="133081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/equine/Richmond/1/2007</a:t>
              </a:r>
              <a:endParaRPr lang="fr-FR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4438317" y="6615264"/>
              <a:ext cx="12009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of substitutions</a:t>
              </a:r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1352891" y="6608678"/>
              <a:ext cx="12009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of substitution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7991719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5174</TotalTime>
  <Words>35</Words>
  <Application>Microsoft Macintosh PowerPoint</Application>
  <PresentationFormat>A4 Paper (210x297 mm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ophie POLLET</dc:creator>
  <cp:lastModifiedBy>Lena Kleij</cp:lastModifiedBy>
  <cp:revision>233</cp:revision>
  <cp:lastPrinted>2023-10-09T13:57:45Z</cp:lastPrinted>
  <dcterms:created xsi:type="dcterms:W3CDTF">2023-02-16T15:54:12Z</dcterms:created>
  <dcterms:modified xsi:type="dcterms:W3CDTF">2023-10-24T12:34:52Z</dcterms:modified>
</cp:coreProperties>
</file>